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79" r:id="rId2"/>
    <p:sldId id="280" r:id="rId3"/>
    <p:sldId id="28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431" autoAdjust="0"/>
  </p:normalViewPr>
  <p:slideViewPr>
    <p:cSldViewPr snapToGrid="0">
      <p:cViewPr varScale="1">
        <p:scale>
          <a:sx n="73" d="100"/>
          <a:sy n="73" d="100"/>
        </p:scale>
        <p:origin x="325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11FEA8-27FF-4A62-9C66-22F490352809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8FE342-7B29-4789-8789-B895F7C435EB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61482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8FE342-7B29-4789-8789-B895F7C435EB}" type="slidenum">
              <a:rPr lang="fr-BE" smtClean="0"/>
              <a:t>3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349832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71163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85829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81379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1082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96538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8167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59473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78354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90073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59604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9413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7188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E85314-9162-D025-F30E-D58BD1E97E9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EB7C1F-18E5-87F0-0280-3EA0BEEC8DF2}"/>
              </a:ext>
            </a:extLst>
          </p:cNvPr>
          <p:cNvSpPr txBox="1"/>
          <p:nvPr/>
        </p:nvSpPr>
        <p:spPr>
          <a:xfrm>
            <a:off x="888275" y="116701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peats of data presented in figure 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FD3929A-6AD3-EE17-FF28-7212F91B7652}"/>
              </a:ext>
            </a:extLst>
          </p:cNvPr>
          <p:cNvSpPr txBox="1"/>
          <p:nvPr/>
        </p:nvSpPr>
        <p:spPr>
          <a:xfrm>
            <a:off x="379132" y="5379303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9Zr – 24h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– individual repeats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3969A399-CC77-7C83-C288-71D54A0B58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3754" y="5798747"/>
            <a:ext cx="1895272" cy="373311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E069CE2-501F-FC60-C7E8-5CF58726CB0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81364" y="5798747"/>
            <a:ext cx="1895272" cy="373311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F71952D-FE61-BA52-A736-AF6035425160}"/>
              </a:ext>
            </a:extLst>
          </p:cNvPr>
          <p:cNvSpPr txBox="1"/>
          <p:nvPr/>
        </p:nvSpPr>
        <p:spPr>
          <a:xfrm>
            <a:off x="853702" y="953666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A9AD24-980E-7C02-56E1-8DD185C9B635}"/>
              </a:ext>
            </a:extLst>
          </p:cNvPr>
          <p:cNvSpPr txBox="1"/>
          <p:nvPr/>
        </p:nvSpPr>
        <p:spPr>
          <a:xfrm>
            <a:off x="2834484" y="953185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ADED7D-118A-09E1-F855-F63350E31595}"/>
              </a:ext>
            </a:extLst>
          </p:cNvPr>
          <p:cNvSpPr txBox="1"/>
          <p:nvPr/>
        </p:nvSpPr>
        <p:spPr>
          <a:xfrm>
            <a:off x="1160921" y="536145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9Zr – 24h – C57BL/6 – individual repeat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0E5EC29-9FB5-6791-F69A-3719E152929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097" y="942503"/>
            <a:ext cx="2059648" cy="373311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99D0921-B0FE-F805-4FF9-1D0DE15F17C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707" y="942503"/>
            <a:ext cx="2059648" cy="373311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12A1D99-BB33-74E7-BE87-E7A0F7872E0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4380" y="930147"/>
            <a:ext cx="2094113" cy="379558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E501AD6-2505-4461-B89E-3D3797EC22F6}"/>
              </a:ext>
            </a:extLst>
          </p:cNvPr>
          <p:cNvSpPr txBox="1"/>
          <p:nvPr/>
        </p:nvSpPr>
        <p:spPr>
          <a:xfrm>
            <a:off x="610069" y="476528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8F021D6-3B6C-74B4-2CDB-E46D68768656}"/>
              </a:ext>
            </a:extLst>
          </p:cNvPr>
          <p:cNvSpPr txBox="1"/>
          <p:nvPr/>
        </p:nvSpPr>
        <p:spPr>
          <a:xfrm>
            <a:off x="2671273" y="477838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F5A2BBA-9F8C-3B8C-E3E3-60D3AF308F38}"/>
              </a:ext>
            </a:extLst>
          </p:cNvPr>
          <p:cNvSpPr txBox="1"/>
          <p:nvPr/>
        </p:nvSpPr>
        <p:spPr>
          <a:xfrm>
            <a:off x="4999855" y="477583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10817144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0FD847E-65BB-D01E-6E75-EF9636882A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BFF58B52-6EE8-1A8C-984D-BB15A20110F5}"/>
              </a:ext>
            </a:extLst>
          </p:cNvPr>
          <p:cNvSpPr txBox="1"/>
          <p:nvPr/>
        </p:nvSpPr>
        <p:spPr>
          <a:xfrm>
            <a:off x="309655" y="4953000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9Zr – 48h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– individual repeat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507F188-90BB-F630-1E95-001284CEFD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5636" y="5384800"/>
            <a:ext cx="1982752" cy="390542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BEA0B91-3578-64A0-3563-81E08F055E0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63098" y="5384800"/>
            <a:ext cx="2012197" cy="390542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8D484DF-7229-9DA8-57CC-65C0790E5834}"/>
              </a:ext>
            </a:extLst>
          </p:cNvPr>
          <p:cNvSpPr txBox="1"/>
          <p:nvPr/>
        </p:nvSpPr>
        <p:spPr>
          <a:xfrm>
            <a:off x="1049802" y="934514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24184C-43CE-6246-E64D-5671F8C212DC}"/>
              </a:ext>
            </a:extLst>
          </p:cNvPr>
          <p:cNvSpPr txBox="1"/>
          <p:nvPr/>
        </p:nvSpPr>
        <p:spPr>
          <a:xfrm>
            <a:off x="3030584" y="934033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252360" y="94309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89Zr – 48h – C57BL/6 – individual repeats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BD6E6996-FD58-99AF-9A89-5290D692032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515" y="685719"/>
            <a:ext cx="2154716" cy="390542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5E4CC4CF-6747-49BA-9462-037720C64E1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8699" y="685719"/>
            <a:ext cx="2154716" cy="390542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96F19ED-F885-11B7-288B-3DF22E7F840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2333" y="673363"/>
            <a:ext cx="2154716" cy="3905422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6B77148-2009-324B-70BC-FCC4BB468A5B}"/>
              </a:ext>
            </a:extLst>
          </p:cNvPr>
          <p:cNvSpPr txBox="1"/>
          <p:nvPr/>
        </p:nvSpPr>
        <p:spPr>
          <a:xfrm>
            <a:off x="680751" y="4616197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7672A01-4748-C91E-C2D2-6D5C097283F5}"/>
              </a:ext>
            </a:extLst>
          </p:cNvPr>
          <p:cNvSpPr txBox="1"/>
          <p:nvPr/>
        </p:nvSpPr>
        <p:spPr>
          <a:xfrm>
            <a:off x="2741955" y="462929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25DEC59-249E-47B0-9527-9E2ABCFD931F}"/>
              </a:ext>
            </a:extLst>
          </p:cNvPr>
          <p:cNvSpPr txBox="1"/>
          <p:nvPr/>
        </p:nvSpPr>
        <p:spPr>
          <a:xfrm>
            <a:off x="5070537" y="462675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27524975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E514B8-A98B-FACB-5883-B21C1ADC4C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E59A0DD0-362B-C461-035D-36984220FCA6}"/>
              </a:ext>
            </a:extLst>
          </p:cNvPr>
          <p:cNvSpPr txBox="1"/>
          <p:nvPr/>
        </p:nvSpPr>
        <p:spPr>
          <a:xfrm>
            <a:off x="1056976" y="5051167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4Cu – 24h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– individual repeats</a:t>
            </a:r>
          </a:p>
        </p:txBody>
      </p:sp>
      <p:pic>
        <p:nvPicPr>
          <p:cNvPr id="4" name="Picture 3" descr="A collage of images of a dog&#10;&#10;AI-generated content may be incorrect.">
            <a:extLst>
              <a:ext uri="{FF2B5EF4-FFF2-40B4-BE49-F238E27FC236}">
                <a16:creationId xmlns:a16="http://schemas.microsoft.com/office/drawing/2014/main" id="{F6CEB320-9D3D-E659-C52B-7D16412007E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599"/>
          <a:stretch/>
        </p:blipFill>
        <p:spPr>
          <a:xfrm>
            <a:off x="294240" y="5475725"/>
            <a:ext cx="1614385" cy="3748329"/>
          </a:xfrm>
          <a:prstGeom prst="rect">
            <a:avLst/>
          </a:prstGeom>
        </p:spPr>
      </p:pic>
      <p:pic>
        <p:nvPicPr>
          <p:cNvPr id="7" name="Picture 6" descr="A collage of images of a dog&#10;&#10;AI-generated content may be incorrect.">
            <a:extLst>
              <a:ext uri="{FF2B5EF4-FFF2-40B4-BE49-F238E27FC236}">
                <a16:creationId xmlns:a16="http://schemas.microsoft.com/office/drawing/2014/main" id="{2DED2101-E191-90A0-3067-B8B90514C89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863" t="-353" r="-994" b="353"/>
          <a:stretch/>
        </p:blipFill>
        <p:spPr>
          <a:xfrm>
            <a:off x="1908625" y="5475724"/>
            <a:ext cx="471777" cy="3748329"/>
          </a:xfrm>
          <a:prstGeom prst="rect">
            <a:avLst/>
          </a:prstGeom>
        </p:spPr>
      </p:pic>
      <p:pic>
        <p:nvPicPr>
          <p:cNvPr id="10" name="Picture 9" descr="A screenshot of a scan of a person's body&#10;&#10;AI-generated content may be incorrect.">
            <a:extLst>
              <a:ext uri="{FF2B5EF4-FFF2-40B4-BE49-F238E27FC236}">
                <a16:creationId xmlns:a16="http://schemas.microsoft.com/office/drawing/2014/main" id="{1B73D04D-11E5-7D53-9EB5-9C32F2DDC01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765"/>
          <a:stretch/>
        </p:blipFill>
        <p:spPr>
          <a:xfrm>
            <a:off x="2472144" y="5462922"/>
            <a:ext cx="1614385" cy="3773931"/>
          </a:xfrm>
          <a:prstGeom prst="rect">
            <a:avLst/>
          </a:prstGeom>
        </p:spPr>
      </p:pic>
      <p:pic>
        <p:nvPicPr>
          <p:cNvPr id="12" name="Picture 11" descr="A screenshot of a scan of a person's body&#10;&#10;AI-generated content may be incorrect.">
            <a:extLst>
              <a:ext uri="{FF2B5EF4-FFF2-40B4-BE49-F238E27FC236}">
                <a16:creationId xmlns:a16="http://schemas.microsoft.com/office/drawing/2014/main" id="{9DBABB35-096B-194F-7166-72D4418B8FC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435" t="-339" r="-577" b="339"/>
          <a:stretch/>
        </p:blipFill>
        <p:spPr>
          <a:xfrm>
            <a:off x="3994786" y="5450122"/>
            <a:ext cx="475754" cy="3773931"/>
          </a:xfrm>
          <a:prstGeom prst="rect">
            <a:avLst/>
          </a:prstGeom>
        </p:spPr>
      </p:pic>
      <p:pic>
        <p:nvPicPr>
          <p:cNvPr id="16" name="Picture 15" descr="A collage of images of a brain&#10;&#10;AI-generated content may be incorrect.">
            <a:extLst>
              <a:ext uri="{FF2B5EF4-FFF2-40B4-BE49-F238E27FC236}">
                <a16:creationId xmlns:a16="http://schemas.microsoft.com/office/drawing/2014/main" id="{744BE6F0-B88D-2067-7C19-216206050C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970"/>
          <a:stretch/>
        </p:blipFill>
        <p:spPr>
          <a:xfrm>
            <a:off x="4678739" y="5450122"/>
            <a:ext cx="1467487" cy="3773931"/>
          </a:xfrm>
          <a:prstGeom prst="rect">
            <a:avLst/>
          </a:prstGeom>
        </p:spPr>
      </p:pic>
      <p:pic>
        <p:nvPicPr>
          <p:cNvPr id="18" name="Picture 17" descr="A collage of images of a brain&#10;&#10;AI-generated content may be incorrect.">
            <a:extLst>
              <a:ext uri="{FF2B5EF4-FFF2-40B4-BE49-F238E27FC236}">
                <a16:creationId xmlns:a16="http://schemas.microsoft.com/office/drawing/2014/main" id="{40DBA432-5BC6-2FBA-AC1D-4CC659A7D38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038" r="-535"/>
          <a:stretch/>
        </p:blipFill>
        <p:spPr>
          <a:xfrm>
            <a:off x="6146226" y="5450122"/>
            <a:ext cx="499387" cy="377393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1CE6F4E-6364-7FE2-84A3-050B8FEC2324}"/>
              </a:ext>
            </a:extLst>
          </p:cNvPr>
          <p:cNvSpPr txBox="1"/>
          <p:nvPr/>
        </p:nvSpPr>
        <p:spPr>
          <a:xfrm>
            <a:off x="894326" y="929222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E24E1FD-4DDD-2536-FA6B-E7B062D24016}"/>
              </a:ext>
            </a:extLst>
          </p:cNvPr>
          <p:cNvSpPr txBox="1"/>
          <p:nvPr/>
        </p:nvSpPr>
        <p:spPr>
          <a:xfrm>
            <a:off x="2875108" y="9287413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23B4851-69F6-F9AA-B1A8-75CFEB670288}"/>
              </a:ext>
            </a:extLst>
          </p:cNvPr>
          <p:cNvSpPr txBox="1"/>
          <p:nvPr/>
        </p:nvSpPr>
        <p:spPr>
          <a:xfrm>
            <a:off x="4829375" y="9300637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286897" y="339560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4Cu – 24h – C57BL/6 – individual repeats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C7220B90-BE18-5D8D-5FA1-74C8759D341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40" y="779024"/>
            <a:ext cx="2043549" cy="370393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2BD2935-0339-5F9A-F4B8-4164618E0EC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978" y="779025"/>
            <a:ext cx="2068044" cy="374832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D48779BD-7CDA-7091-C11E-5BD4A6E8BC2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7569" y="757259"/>
            <a:ext cx="2068044" cy="3748329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3A4375AF-920C-20A5-F4D0-853C9FC8E574}"/>
              </a:ext>
            </a:extLst>
          </p:cNvPr>
          <p:cNvSpPr txBox="1"/>
          <p:nvPr/>
        </p:nvSpPr>
        <p:spPr>
          <a:xfrm>
            <a:off x="705830" y="447240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BF7D861-D15C-A009-BA92-90BC227668D3}"/>
              </a:ext>
            </a:extLst>
          </p:cNvPr>
          <p:cNvSpPr txBox="1"/>
          <p:nvPr/>
        </p:nvSpPr>
        <p:spPr>
          <a:xfrm>
            <a:off x="2767034" y="448550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5507ADD-8457-014A-E353-342CFBFB6C71}"/>
              </a:ext>
            </a:extLst>
          </p:cNvPr>
          <p:cNvSpPr txBox="1"/>
          <p:nvPr/>
        </p:nvSpPr>
        <p:spPr>
          <a:xfrm>
            <a:off x="5095616" y="448295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1939732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00</Words>
  <Application>Microsoft Office PowerPoint</Application>
  <PresentationFormat>A4 Paper (210x297 mm)</PresentationFormat>
  <Paragraphs>2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omas Balligand</dc:creator>
  <cp:lastModifiedBy>Thomas Balligand</cp:lastModifiedBy>
  <cp:revision>6</cp:revision>
  <dcterms:created xsi:type="dcterms:W3CDTF">2025-07-24T09:24:58Z</dcterms:created>
  <dcterms:modified xsi:type="dcterms:W3CDTF">2025-07-24T09:36:35Z</dcterms:modified>
</cp:coreProperties>
</file>